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6" r:id="rId3"/>
    <p:sldId id="261" r:id="rId4"/>
    <p:sldId id="259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0220DF-ED28-4D96-8C3B-91363A0EFDA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F16FA14-A81F-4DD0-ABC9-88AF64B596E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8E5382-FF25-4605-B004-DE6EEF01BF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3F5268-9A2E-4D93-B063-513C3B5B88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867394-CD5B-41FB-9142-E0DC116A5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581649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060984-FCF3-463D-8E5B-29B3224B1E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0DEF65E-7F55-47AD-9519-B30AA88575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8BD743-14FB-409F-8B01-2EB889611E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18A255-FCBF-4214-9A54-0354C3503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6D5371-D915-432C-9B35-CF1A7BDE4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194187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0DA2EB2-D641-44BD-9C44-6F5E04C4AA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B3570C-8718-45BC-AEE2-E2F85EBD0E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522274-6512-45C6-AD9B-9D7FE4B0C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A0CA827-5FED-4044-B521-AB0E3C719A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4C7C21-81D7-4BEF-8C15-BF4143B5AE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012683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42C012-BBB1-41E8-8736-FF0AB4B750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251E0D7-71D7-4942-9DF4-FA2CB3B281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E668BC-C016-4DC4-84EA-9B7AAFA599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2B60B32-7AA8-4D4E-902A-EBA32BD1383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5A74D1-1C57-4F1C-8067-110FE34D21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38727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1DDAB8-4F81-4A17-80BC-76633A9ED9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F334B5-8B17-4D39-AB49-DFF22B5CD1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AC00D40-DC60-4A34-A1C4-9B5874513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7E5E17-7607-43B7-8202-53D3431807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20952B5-C7DD-453C-8B01-28AC223856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311348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7E575D7-2E91-4A0C-82E8-E91BDA4EE2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97EEA8-4021-41B2-9303-3946818D42B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6712FEB-771B-4915-8934-F0F1874AD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80A0A3E-2F24-4B92-A6A2-3869772E96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6E4B343-01AD-4388-9836-E698F45F29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4470A27-7655-41AA-9555-F818AA2E3D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199846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1E1C7C-0FD8-46DD-9127-558E401D24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D7CCED0-10DC-4B11-A59C-C8D21817F9B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E8D5B50-4A78-4C1A-B3AC-659BF01EED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57A9B6-CC1F-4B5C-8B1B-55B748835F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3AB75D-88C6-43B6-9497-503DACF9EAB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AA94A0CA-3C67-4602-AFC2-2ED826C0E5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F22D57F-DEDF-47CA-A33F-A5549DE873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AFC418C4-67F7-4E96-8038-3AF68FD52E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938139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E91661-881E-44BB-BE55-3104FA133E5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4783F13-1B5C-4387-B62D-129B977662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08FEF86-E194-4660-82C3-7B8BFBAB3B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CDF6C64-E733-4166-BA21-9F1818B92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701033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8EC3554-EDDF-4BEB-8BFE-6A7BAE0C82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57D03DE-6F5A-4CD3-A977-5CE5C0445F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5B3327-483E-4DC9-A0CD-34D98BDEF5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330637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6A73E78-FC57-4791-9345-A317DCD21C6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A7509C7-61E2-482A-8D0A-4CC7B92F61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487E471-A5F4-49AA-BCB9-E1413878F33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4D03D31-D674-4FC5-AB32-F47CC14B13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1198D2-E3BF-40DB-A98D-38683F29B5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40F001-38AF-4394-AF78-0545D6C9F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39610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23C67-1D25-420C-BBA2-13FA2F97E3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93E7729-C287-47D7-A407-A8589BD7102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F21A532-08B0-4B46-9062-FB7D2DDB93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B8A49F3-8DE3-49F3-BF38-7E5334F3AE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003A71-237F-4339-AA02-3CC9A1D510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F8F2C4-433B-4D79-9C83-67F6269136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62327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6C2B88-319D-47FF-9FDB-F30DAF5380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CAE98B-0AC2-46CF-97E2-F1A98D08F3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AAECC7-9275-49FE-8491-0724BF21F97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F920C7-CD75-48D0-A713-36913AE854EB}" type="datetimeFigureOut">
              <a:rPr lang="en-IN" smtClean="0"/>
              <a:t>12-08-2020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275BD3-D0C8-4EEE-BE42-791E01E6544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3E7049-ECD5-47F5-B0AC-DDF6225C237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94DC27-0DBB-41AC-B679-551A3CE9691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060332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5A41078-3EF4-48E1-89E0-83EE7987A17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883" y="0"/>
            <a:ext cx="5265906" cy="685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F63FE87-20A4-4BFC-9274-B34D51EE79D3}"/>
              </a:ext>
            </a:extLst>
          </p:cNvPr>
          <p:cNvSpPr txBox="1"/>
          <p:nvPr/>
        </p:nvSpPr>
        <p:spPr>
          <a:xfrm>
            <a:off x="6782540" y="1410231"/>
            <a:ext cx="48544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igure S1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PI Network of the genes regulated after capsaicin treatment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30161674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C12EAFCF-C168-48A3-A96B-027C25E1A730}"/>
              </a:ext>
            </a:extLst>
          </p:cNvPr>
          <p:cNvGrpSpPr/>
          <p:nvPr/>
        </p:nvGrpSpPr>
        <p:grpSpPr>
          <a:xfrm>
            <a:off x="2535719" y="0"/>
            <a:ext cx="6553684" cy="6858000"/>
            <a:chOff x="2535719" y="0"/>
            <a:chExt cx="6553684" cy="6858000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A5BE217-A19D-43C0-9653-C186D25B178A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35719" y="0"/>
              <a:ext cx="6553684" cy="6312023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2090A3D1-8061-4CBE-BDA3-E6D9252CC05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0340" t="50000" r="26966" b="39547"/>
            <a:stretch/>
          </p:blipFill>
          <p:spPr>
            <a:xfrm>
              <a:off x="2938508" y="6141128"/>
              <a:ext cx="3986075" cy="716872"/>
            </a:xfrm>
            <a:prstGeom prst="rect">
              <a:avLst/>
            </a:prstGeom>
          </p:spPr>
        </p:pic>
      </p:grpSp>
      <p:sp>
        <p:nvSpPr>
          <p:cNvPr id="9" name="TextBox 8">
            <a:extLst>
              <a:ext uri="{FF2B5EF4-FFF2-40B4-BE49-F238E27FC236}">
                <a16:creationId xmlns:a16="http://schemas.microsoft.com/office/drawing/2014/main" id="{0F8EDDBE-A1D6-47EB-AECE-FB4E99B76A87}"/>
              </a:ext>
            </a:extLst>
          </p:cNvPr>
          <p:cNvSpPr txBox="1"/>
          <p:nvPr/>
        </p:nvSpPr>
        <p:spPr>
          <a:xfrm>
            <a:off x="9379390" y="1410231"/>
            <a:ext cx="225763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igure S2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PI Extended Network of the genes regulated after capsaicin treatment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272781359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58DA1732-4E05-4215-B2B6-8DEFCD1B566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8543" y="0"/>
            <a:ext cx="8226293" cy="68580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831DDBA-2D4C-4691-A8EA-91D6239A3840}"/>
              </a:ext>
            </a:extLst>
          </p:cNvPr>
          <p:cNvSpPr txBox="1"/>
          <p:nvPr/>
        </p:nvSpPr>
        <p:spPr>
          <a:xfrm>
            <a:off x="8131946" y="1410231"/>
            <a:ext cx="350507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igure S3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PI Network of the genes regulated after RTX treatment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29284346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B1B92A69-FBD9-4834-B9D4-CEF08141006B}"/>
              </a:ext>
            </a:extLst>
          </p:cNvPr>
          <p:cNvGrpSpPr/>
          <p:nvPr/>
        </p:nvGrpSpPr>
        <p:grpSpPr>
          <a:xfrm>
            <a:off x="1731146" y="0"/>
            <a:ext cx="6847552" cy="6680446"/>
            <a:chOff x="1731146" y="0"/>
            <a:chExt cx="6847552" cy="6680446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2491F41-8605-412A-9687-DDF6E6959F06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731146" y="0"/>
              <a:ext cx="6847552" cy="588197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9C71337-4DF5-460E-854B-C7DDE924355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40340" t="50000" r="26966" b="39547"/>
            <a:stretch/>
          </p:blipFill>
          <p:spPr>
            <a:xfrm>
              <a:off x="3266982" y="5963574"/>
              <a:ext cx="3986075" cy="716872"/>
            </a:xfrm>
            <a:prstGeom prst="rect">
              <a:avLst/>
            </a:prstGeom>
          </p:spPr>
        </p:pic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4DC21833-8054-42EF-AB6A-C40E60F505F5}"/>
              </a:ext>
            </a:extLst>
          </p:cNvPr>
          <p:cNvSpPr txBox="1"/>
          <p:nvPr/>
        </p:nvSpPr>
        <p:spPr>
          <a:xfrm>
            <a:off x="9379390" y="1410231"/>
            <a:ext cx="2257630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b="1" dirty="0"/>
              <a:t>Figure S4.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等线" panose="02010600030101010101" pitchFamily="2" charset="-122"/>
              </a:rPr>
              <a:t>PPI Extended Network of the genes regulated after RTX treatment</a:t>
            </a:r>
            <a:endParaRPr lang="en-IN" b="1" dirty="0"/>
          </a:p>
        </p:txBody>
      </p:sp>
    </p:spTree>
    <p:extLst>
      <p:ext uri="{BB962C8B-B14F-4D97-AF65-F5344CB8AC3E}">
        <p14:creationId xmlns:p14="http://schemas.microsoft.com/office/powerpoint/2010/main" val="3146059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</TotalTime>
  <Words>50</Words>
  <Application>Microsoft Office PowerPoint</Application>
  <PresentationFormat>Widescreen</PresentationFormat>
  <Paragraphs>4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Administrator</cp:lastModifiedBy>
  <cp:revision>10</cp:revision>
  <dcterms:created xsi:type="dcterms:W3CDTF">2020-08-07T04:40:35Z</dcterms:created>
  <dcterms:modified xsi:type="dcterms:W3CDTF">2020-08-12T06:31:11Z</dcterms:modified>
</cp:coreProperties>
</file>